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DDFF"/>
    <a:srgbClr val="4FE6FF"/>
    <a:srgbClr val="003A5D"/>
    <a:srgbClr val="00BF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3"/>
    <p:restoredTop sz="94654"/>
  </p:normalViewPr>
  <p:slideViewPr>
    <p:cSldViewPr snapToGrid="0" snapToObjects="1">
      <p:cViewPr varScale="1">
        <p:scale>
          <a:sx n="78" d="100"/>
          <a:sy n="78" d="100"/>
        </p:scale>
        <p:origin x="586" y="58"/>
      </p:cViewPr>
      <p:guideLst>
        <p:guide orient="horz" pos="348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 showGuides="1">
      <p:cViewPr varScale="1">
        <p:scale>
          <a:sx n="62" d="100"/>
          <a:sy n="62" d="100"/>
        </p:scale>
        <p:origin x="3154" y="7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88FD3E-1513-4922-836E-69C1F2565848}" type="datetimeFigureOut">
              <a:rPr lang="en-US" smtClean="0"/>
              <a:t>9/3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5979F9-6F6C-4B1C-8474-9809D7DAE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6379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5979F9-6F6C-4B1C-8474-9809D7DAE21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4548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9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56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9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486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9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223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9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102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9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977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9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029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9/3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83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9/3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792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9/3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11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9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5088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9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617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805A4-B662-294F-9DA1-5D9B91FD62B8}" type="datetimeFigureOut">
              <a:rPr lang="en-US" smtClean="0"/>
              <a:t>9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519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6AB67B-F644-49E3-B9C9-2951F830C7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4581" y="0"/>
            <a:ext cx="11642838" cy="1137055"/>
          </a:xfrm>
        </p:spPr>
        <p:txBody>
          <a:bodyPr>
            <a:normAutofit/>
          </a:bodyPr>
          <a:lstStyle/>
          <a:p>
            <a:pPr algn="ctr"/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Novel Automated Suturing Technology for Minimally Invasive Mitral Chord Implantation: A Preclinical Evaluation Study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54CF4FF-198F-4038-A94A-73E2DD96E73F}"/>
              </a:ext>
            </a:extLst>
          </p:cNvPr>
          <p:cNvGrpSpPr/>
          <p:nvPr/>
        </p:nvGrpSpPr>
        <p:grpSpPr>
          <a:xfrm>
            <a:off x="274581" y="1137055"/>
            <a:ext cx="11642838" cy="4453641"/>
            <a:chOff x="274581" y="1137055"/>
            <a:chExt cx="11642838" cy="4453641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A66F968-4A60-40CC-ABF8-1715250DD3A4}"/>
                </a:ext>
              </a:extLst>
            </p:cNvPr>
            <p:cNvSpPr/>
            <p:nvPr/>
          </p:nvSpPr>
          <p:spPr>
            <a:xfrm>
              <a:off x="274581" y="1137055"/>
              <a:ext cx="3880946" cy="4453641"/>
            </a:xfrm>
            <a:prstGeom prst="rect">
              <a:avLst/>
            </a:prstGeom>
            <a:solidFill>
              <a:srgbClr val="00BFD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THODOLOGY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practicing adult cardiac surgeons performed chordal replacements in cadaver hearts under open and MICS access using novel technology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C2BD41FA-277E-48C9-A86D-24E908BEAB43}"/>
                </a:ext>
              </a:extLst>
            </p:cNvPr>
            <p:cNvSpPr/>
            <p:nvPr/>
          </p:nvSpPr>
          <p:spPr>
            <a:xfrm>
              <a:off x="4155527" y="1137055"/>
              <a:ext cx="3880946" cy="4453641"/>
            </a:xfrm>
            <a:prstGeom prst="rect">
              <a:avLst/>
            </a:prstGeom>
            <a:solidFill>
              <a:srgbClr val="11DD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CHNIQUE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 synthetic chords were placed using novel automated suturing and knotting technology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2BDD0B3E-97C4-4961-85FC-17F984B231B4}"/>
                </a:ext>
              </a:extLst>
            </p:cNvPr>
            <p:cNvSpPr/>
            <p:nvPr/>
          </p:nvSpPr>
          <p:spPr>
            <a:xfrm>
              <a:off x="8036473" y="1137055"/>
              <a:ext cx="3880946" cy="4453641"/>
            </a:xfrm>
            <a:prstGeom prst="rect">
              <a:avLst/>
            </a:prstGeom>
            <a:solidFill>
              <a:srgbClr val="00BFD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UTCOME</a:t>
              </a:r>
            </a:p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vel technology demonstrated short learning curves and excellent control of suture delivery that may enhance less invasive mitral valve procedures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F1067D66-3B18-4C13-BE99-9FADBCAC927E}"/>
              </a:ext>
            </a:extLst>
          </p:cNvPr>
          <p:cNvGrpSpPr/>
          <p:nvPr/>
        </p:nvGrpSpPr>
        <p:grpSpPr>
          <a:xfrm>
            <a:off x="274581" y="5590696"/>
            <a:ext cx="11642838" cy="1267304"/>
            <a:chOff x="274581" y="5590696"/>
            <a:chExt cx="11642838" cy="1267304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5C1BC0D-3D40-4F7D-9935-BB8BC885EA74}"/>
                </a:ext>
              </a:extLst>
            </p:cNvPr>
            <p:cNvSpPr txBox="1"/>
            <p:nvPr/>
          </p:nvSpPr>
          <p:spPr>
            <a:xfrm>
              <a:off x="3204022" y="6627168"/>
              <a:ext cx="57262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@Innovationsjour | Copyright © The Author(s) 2022. All rights reserved. Published by SAGE Publishing Inc.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0300ED5C-CD19-4926-A571-D5CC9C00EE6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4581" y="5590696"/>
              <a:ext cx="11642838" cy="1036472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A0A69DF-628C-48B0-9981-44EBE0D1E2AA}"/>
                </a:ext>
              </a:extLst>
            </p:cNvPr>
            <p:cNvSpPr txBox="1"/>
            <p:nvPr/>
          </p:nvSpPr>
          <p:spPr>
            <a:xfrm>
              <a:off x="4026773" y="6280919"/>
              <a:ext cx="4781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erner et al. </a:t>
              </a:r>
              <a:r>
                <a:rPr lang="en-US" sz="14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novations</a:t>
              </a:r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 November/December 2022.</a:t>
              </a:r>
            </a:p>
          </p:txBody>
        </p:sp>
      </p:grpSp>
      <p:pic>
        <p:nvPicPr>
          <p:cNvPr id="6" name="Grafik 8">
            <a:extLst>
              <a:ext uri="{FF2B5EF4-FFF2-40B4-BE49-F238E27FC236}">
                <a16:creationId xmlns:a16="http://schemas.microsoft.com/office/drawing/2014/main" id="{31CCABF4-F388-9221-6688-7A134B9850D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8663" y="3701747"/>
            <a:ext cx="2898769" cy="1839604"/>
          </a:xfrm>
          <a:prstGeom prst="rect">
            <a:avLst/>
          </a:prstGeom>
        </p:spPr>
      </p:pic>
      <p:pic>
        <p:nvPicPr>
          <p:cNvPr id="7" name="Grafik 22">
            <a:extLst>
              <a:ext uri="{FF2B5EF4-FFF2-40B4-BE49-F238E27FC236}">
                <a16:creationId xmlns:a16="http://schemas.microsoft.com/office/drawing/2014/main" id="{E47C16F5-99CC-3207-3309-4F18D250BCB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53244" y="3157200"/>
            <a:ext cx="2485512" cy="2377132"/>
          </a:xfrm>
          <a:prstGeom prst="rect">
            <a:avLst/>
          </a:prstGeom>
          <a:effectLst>
            <a:outerShdw blurRad="279400" dist="38100" dir="2700000" sx="104000" sy="104000" algn="tl" rotWithShape="0">
              <a:prstClr val="black">
                <a:alpha val="40000"/>
              </a:prstClr>
            </a:outerShdw>
          </a:effectLst>
        </p:spPr>
      </p:pic>
      <p:pic>
        <p:nvPicPr>
          <p:cNvPr id="8" name="Grafik 12">
            <a:extLst>
              <a:ext uri="{FF2B5EF4-FFF2-40B4-BE49-F238E27FC236}">
                <a16:creationId xmlns:a16="http://schemas.microsoft.com/office/drawing/2014/main" id="{878CE412-E28F-5F75-6DC4-94D962A7C4E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64658" y="3678887"/>
            <a:ext cx="3024575" cy="19144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1556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</TotalTime>
  <Words>103</Words>
  <Application>Microsoft Office PowerPoint</Application>
  <PresentationFormat>Widescreen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Novel Automated Suturing Technology for Minimally Invasive Mitral Chord Implantation: A Preclinical Evaluation Study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t Kiesel</dc:creator>
  <cp:lastModifiedBy>Sari D. Holmes, PhD</cp:lastModifiedBy>
  <cp:revision>17</cp:revision>
  <dcterms:created xsi:type="dcterms:W3CDTF">2019-04-26T22:59:25Z</dcterms:created>
  <dcterms:modified xsi:type="dcterms:W3CDTF">2022-09-30T20:03:58Z</dcterms:modified>
</cp:coreProperties>
</file>